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81790"/>
  </p:normalViewPr>
  <p:slideViewPr>
    <p:cSldViewPr snapToGrid="0" snapToObjects="1">
      <p:cViewPr varScale="1">
        <p:scale>
          <a:sx n="86" d="100"/>
          <a:sy n="86" d="100"/>
        </p:scale>
        <p:origin x="149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9DB64C4E-71FB-AB4C-BC45-D83F8292541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7A94D67-11FE-A04E-905B-847A58A94E6B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416ED9-0D0A-6841-8BA9-777C2B97BD22}" type="datetimeFigureOut">
              <a:rPr lang="en-US" smtClean="0"/>
              <a:t>1/16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282BD8C-7313-1244-90BE-D5687ECCCB6A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18DAFC9-34DB-F541-A15E-F8925BB7B29F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275C87-55B5-A646-8B73-5D3344D63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03884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D8A5DC-869A-054B-BB5F-7B99871F0CD4}" type="datetimeFigureOut">
              <a:rPr lang="en-US" smtClean="0"/>
              <a:t>1/16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0DE253-02CB-2F46-8057-88F2B6C9A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1426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o print this cognitive aid, please print “Handouts,” two per page.</a:t>
            </a:r>
          </a:p>
          <a:p>
            <a:r>
              <a:rPr lang="en-US" dirty="0"/>
              <a:t>Once printed, cut the page in half.</a:t>
            </a:r>
            <a:br>
              <a:rPr lang="en-US" dirty="0"/>
            </a:br>
            <a:r>
              <a:rPr lang="en-US" dirty="0"/>
              <a:t>One can consider laminating as well.</a:t>
            </a:r>
          </a:p>
          <a:p>
            <a:r>
              <a:rPr lang="en-US" dirty="0"/>
              <a:t>Once cut down, this aid should fit nicely into a PALS card or into a typical doctor’s white coat or scrub </a:t>
            </a:r>
            <a:r>
              <a:rPr lang="en-US"/>
              <a:t>pant pocket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0DE253-02CB-2F46-8057-88F2B6C9A9F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4801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029FFA-7F9D-E744-AEFA-BD5F85A55D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2C21664-8D5A-DE43-B832-B1336B1CF1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BF9F52-007B-B745-8050-BB25FD2EB9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0C519-7C76-F042-891F-AD05DC453E60}" type="datetimeFigureOut">
              <a:rPr lang="en-US" smtClean="0"/>
              <a:t>1/1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792F04-EE68-7F41-9233-F7FF59454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7EDB4E-2DF9-ED49-BDA3-ED4F49E5DD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CCE2E-185A-7C45-B760-63395E4C0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41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14B374-1B6C-054F-896F-F31FCD20EF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768BBB-421F-F64E-BE7B-703F42D37E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401733-3A9A-EB47-96A4-358380244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0C519-7C76-F042-891F-AD05DC453E60}" type="datetimeFigureOut">
              <a:rPr lang="en-US" smtClean="0"/>
              <a:t>1/1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E9C82A-D525-BC4F-9A7E-DDF5A934C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B6EA69-90EA-7F44-815B-18A1614B65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CCE2E-185A-7C45-B760-63395E4C0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434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5EE41E7-EAA4-C34E-8BDD-477846D4C9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A83100-4DF5-9548-AF1F-962F8888FE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6C39AF-F2C3-E54D-BB9D-ACF72080E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0C519-7C76-F042-891F-AD05DC453E60}" type="datetimeFigureOut">
              <a:rPr lang="en-US" smtClean="0"/>
              <a:t>1/1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B4653A-7500-C94C-9C7B-FAEE577C71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AD61CC-CF83-7A41-88FF-E1A3843410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CCE2E-185A-7C45-B760-63395E4C0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585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6E985B-E62C-9A41-B36C-9FA19CA22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E52093-9AA4-6D45-8DF6-4451B2176E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1B4D93-0E3D-E048-97B9-ECF71E55FC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0C519-7C76-F042-891F-AD05DC453E60}" type="datetimeFigureOut">
              <a:rPr lang="en-US" smtClean="0"/>
              <a:t>1/1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007C1E-B20B-1E43-AAB2-D4766B05A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D6F602-5106-BF43-BA94-C966355CF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CCE2E-185A-7C45-B760-63395E4C0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0196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4FC2B1-148F-1F4C-B37F-9A7920B7F8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D20BE3-C140-5545-AE78-201C8CCB0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53AAAD-1DE4-A645-90A6-5C63C7571D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0C519-7C76-F042-891F-AD05DC453E60}" type="datetimeFigureOut">
              <a:rPr lang="en-US" smtClean="0"/>
              <a:t>1/1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D30167-35FE-F24D-8B88-27D2E5D24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B58D5B-DD03-4841-B7E7-C52932C26D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CCE2E-185A-7C45-B760-63395E4C0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386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2B4197-B04C-B24C-97BD-4C9C882CF9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E339CC-3FD0-8842-A1E0-A49ECECEB5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929C82-ECA6-A04C-A41D-6F6790E84F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061537-2DDC-7945-8801-1BC77375FF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0C519-7C76-F042-891F-AD05DC453E60}" type="datetimeFigureOut">
              <a:rPr lang="en-US" smtClean="0"/>
              <a:t>1/16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67FF73-060A-B441-993C-FF20650CFE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CE129E-EA68-9745-AD06-2205F3F62F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CCE2E-185A-7C45-B760-63395E4C0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445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5D5D7A-888B-3844-8761-4DFF1562D0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FDF49A-F5FD-114E-9C28-CF21603E7B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0985CB-BA36-894A-BCE8-70551F2626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EC88FC9-E6B1-4542-A3B3-FA3C774C00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2482905-1753-9E48-97AD-FCE78CB7E7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8D63646-7A11-5141-B703-3AACC976C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0C519-7C76-F042-891F-AD05DC453E60}" type="datetimeFigureOut">
              <a:rPr lang="en-US" smtClean="0"/>
              <a:t>1/16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449AB1F-C03D-4A4C-8D34-CEDED59CE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677AF0-5BA5-A24E-A98A-12EDCCFC4E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CCE2E-185A-7C45-B760-63395E4C0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928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5238E6-8C26-0F41-A710-A0CA5AB9A7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B7C4614-706F-7E4C-9537-8E5668D1CF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0C519-7C76-F042-891F-AD05DC453E60}" type="datetimeFigureOut">
              <a:rPr lang="en-US" smtClean="0"/>
              <a:t>1/16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BE832C6-3BE9-FF4C-AA88-332807206B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70089B7-FF7F-1247-ABE6-B0D31670F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CCE2E-185A-7C45-B760-63395E4C0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170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1E85608-09FD-7848-90BA-B21D67592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0C519-7C76-F042-891F-AD05DC453E60}" type="datetimeFigureOut">
              <a:rPr lang="en-US" smtClean="0"/>
              <a:t>1/16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4A32AB0-27FE-C141-9069-14430148E1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A1B4DDA-732A-2440-A827-BF45DE4E0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CCE2E-185A-7C45-B760-63395E4C0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716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EAE543-1D91-4F41-8E6D-345718C4AD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5669A4-5842-DC40-810E-C86FE9F964C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93D6F5-84A8-D642-82CE-40215926AA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AAE537-F356-5F4B-9035-B42DAA68E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0C519-7C76-F042-891F-AD05DC453E60}" type="datetimeFigureOut">
              <a:rPr lang="en-US" smtClean="0"/>
              <a:t>1/16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29E79A-6C52-814E-851D-21884B347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F2260A-B3C7-5247-A127-29DA112B49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CCE2E-185A-7C45-B760-63395E4C0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843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20F999-B173-D845-92A3-1DB3931DBA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1F2F180-1FD7-E042-9E09-666C29EB5B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D8A3C0-F2C3-F142-9B8A-B2AF5293BF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C335D3-D47B-7941-8E24-25EF2CECEC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0C519-7C76-F042-891F-AD05DC453E60}" type="datetimeFigureOut">
              <a:rPr lang="en-US" smtClean="0"/>
              <a:t>1/16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CE8E80-F4E2-F647-90D1-98DD96C833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E8B0D6-86A3-BC40-BC09-78B01D02C8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CCE2E-185A-7C45-B760-63395E4C0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810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3EEECE9-98F8-C043-AA1D-EFD7CB17D7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69E4EB-D1A3-D346-92F8-3BC924BAF0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B9613A-0AFD-7E42-B90E-9ED380E7A1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50C519-7C76-F042-891F-AD05DC453E60}" type="datetimeFigureOut">
              <a:rPr lang="en-US" smtClean="0"/>
              <a:t>1/1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7B7421-4367-A046-94E9-CE2C69001A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982158-65E7-8344-8930-133C56003B8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FCCE2E-185A-7C45-B760-63395E4C0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816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407E899-56B8-F14D-96CE-38536CBAAF29}"/>
              </a:ext>
            </a:extLst>
          </p:cNvPr>
          <p:cNvSpPr txBox="1"/>
          <p:nvPr/>
        </p:nvSpPr>
        <p:spPr>
          <a:xfrm>
            <a:off x="0" y="972007"/>
            <a:ext cx="3580667" cy="60939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/>
              <a:t>Indications</a:t>
            </a:r>
            <a:r>
              <a:rPr lang="en-US" dirty="0"/>
              <a:t>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Proximal Obstructions (only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Severe facial trauma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Can’t Intubate, Can’t Ventilate from above!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  <a:p>
            <a:r>
              <a:rPr lang="en-US" b="1" u="sng" dirty="0"/>
              <a:t>Equipment</a:t>
            </a:r>
            <a:r>
              <a:rPr lang="en-US" dirty="0"/>
              <a:t>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Self Inflating Ventilation Bag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7.0 ETT Connecto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3mL Syringe Barrel (plunger removed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14g IV Catheter loaded on a small saline filled syring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200" dirty="0"/>
              <a:t>Without automatic retracting needl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  <a:p>
            <a:r>
              <a:rPr lang="en-US" b="1" u="sng" dirty="0"/>
              <a:t>Tips</a:t>
            </a:r>
            <a:r>
              <a:rPr lang="en-US" dirty="0"/>
              <a:t>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Insert Needle Caudally at a 30-45 Degree Angl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llow long expiration time while bagging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b="1" i="1" dirty="0"/>
              <a:t>Call for HELP!!!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624394B-F3D2-8A4A-BB41-0B6FF6AAC8BA}"/>
              </a:ext>
            </a:extLst>
          </p:cNvPr>
          <p:cNvSpPr txBox="1"/>
          <p:nvPr/>
        </p:nvSpPr>
        <p:spPr>
          <a:xfrm>
            <a:off x="33866" y="290549"/>
            <a:ext cx="346601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i="1" u="sng" dirty="0"/>
              <a:t>Needle </a:t>
            </a:r>
            <a:r>
              <a:rPr lang="en-US" sz="3200" b="1" i="1" u="sng" dirty="0" err="1"/>
              <a:t>Crics</a:t>
            </a:r>
            <a:r>
              <a:rPr lang="en-US" sz="3200" b="1" i="1" u="sng" dirty="0"/>
              <a:t> in Kid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12F66CA-0F33-FB4B-995B-5CB65DEED191}"/>
              </a:ext>
            </a:extLst>
          </p:cNvPr>
          <p:cNvSpPr txBox="1"/>
          <p:nvPr/>
        </p:nvSpPr>
        <p:spPr>
          <a:xfrm>
            <a:off x="8831318" y="6555600"/>
            <a:ext cx="1980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Goldman, M. Author Owned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915AF22-C2D9-ED47-9C90-EE543E870F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32961" y="152400"/>
            <a:ext cx="4751601" cy="633546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EA92091-7A73-444C-A928-56370140DF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50890" y="3226819"/>
            <a:ext cx="2448240" cy="326432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722AEED6-857C-0F4D-B728-F7D56375C117}"/>
              </a:ext>
            </a:extLst>
          </p:cNvPr>
          <p:cNvSpPr txBox="1"/>
          <p:nvPr/>
        </p:nvSpPr>
        <p:spPr>
          <a:xfrm>
            <a:off x="4752818" y="6583220"/>
            <a:ext cx="1980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Goldman, M. Author Owned.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C1273A9-3A2E-E647-A15A-C1AE2D48D3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5400000">
            <a:off x="5393222" y="1472154"/>
            <a:ext cx="1718259" cy="1288694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C4337E5B-673C-744B-8EBC-8A5401682F07}"/>
              </a:ext>
            </a:extLst>
          </p:cNvPr>
          <p:cNvSpPr txBox="1"/>
          <p:nvPr/>
        </p:nvSpPr>
        <p:spPr>
          <a:xfrm>
            <a:off x="4659902" y="2972710"/>
            <a:ext cx="1980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Goldman, M. Author Owned.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4E4B256D-47BD-E148-8AE0-1C5C11FBD4A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5400000">
            <a:off x="4136541" y="1472261"/>
            <a:ext cx="1714798" cy="128609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9AEF8B1-3876-294C-AD9B-377B055F532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97894" y="168282"/>
            <a:ext cx="1082924" cy="81219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5A197FB-EF36-6E43-AD84-65116EA48E98}"/>
              </a:ext>
            </a:extLst>
          </p:cNvPr>
          <p:cNvSpPr txBox="1"/>
          <p:nvPr/>
        </p:nvSpPr>
        <p:spPr>
          <a:xfrm>
            <a:off x="4600417" y="995220"/>
            <a:ext cx="1980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Goldman, M. Author Owned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6B82615-2BCB-D544-9A2E-9E2AC474F19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608004" y="174169"/>
            <a:ext cx="1063784" cy="7978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22516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407E899-56B8-F14D-96CE-38536CBAAF29}"/>
              </a:ext>
            </a:extLst>
          </p:cNvPr>
          <p:cNvSpPr txBox="1"/>
          <p:nvPr/>
        </p:nvSpPr>
        <p:spPr>
          <a:xfrm>
            <a:off x="0" y="972007"/>
            <a:ext cx="3580667" cy="60939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/>
              <a:t>Indications</a:t>
            </a:r>
            <a:r>
              <a:rPr lang="en-US" dirty="0"/>
              <a:t>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Proximal Obstructions (only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Severe facial trauma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Can’t Intubate, Can’t Ventilate from above!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  <a:p>
            <a:r>
              <a:rPr lang="en-US" b="1" u="sng" dirty="0"/>
              <a:t>Equipment</a:t>
            </a:r>
            <a:r>
              <a:rPr lang="en-US" dirty="0"/>
              <a:t>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Self Inflating Ventilation Bag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7.0 ETT Connecto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3mL Syringe Barrel (plunger removed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14g IV Catheter loaded on a small saline filled syring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200" dirty="0"/>
              <a:t>Without automatic retracting needl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  <a:p>
            <a:r>
              <a:rPr lang="en-US" b="1" u="sng" dirty="0"/>
              <a:t>Tips</a:t>
            </a:r>
            <a:r>
              <a:rPr lang="en-US" dirty="0"/>
              <a:t>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Insert Needle Caudally at a 30-45 Degree Angl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llow long expiration time while bagging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b="1" i="1" dirty="0"/>
              <a:t>Call for HELP!!!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624394B-F3D2-8A4A-BB41-0B6FF6AAC8BA}"/>
              </a:ext>
            </a:extLst>
          </p:cNvPr>
          <p:cNvSpPr txBox="1"/>
          <p:nvPr/>
        </p:nvSpPr>
        <p:spPr>
          <a:xfrm>
            <a:off x="33866" y="290549"/>
            <a:ext cx="346601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i="1" u="sng" dirty="0"/>
              <a:t>Needle </a:t>
            </a:r>
            <a:r>
              <a:rPr lang="en-US" sz="3200" b="1" i="1" u="sng" dirty="0" err="1"/>
              <a:t>Crics</a:t>
            </a:r>
            <a:r>
              <a:rPr lang="en-US" sz="3200" b="1" i="1" u="sng" dirty="0"/>
              <a:t> in Kid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12F66CA-0F33-FB4B-995B-5CB65DEED191}"/>
              </a:ext>
            </a:extLst>
          </p:cNvPr>
          <p:cNvSpPr txBox="1"/>
          <p:nvPr/>
        </p:nvSpPr>
        <p:spPr>
          <a:xfrm>
            <a:off x="8831318" y="6555600"/>
            <a:ext cx="1980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Goldman, M. Author Owned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915AF22-C2D9-ED47-9C90-EE543E870F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32961" y="152400"/>
            <a:ext cx="4751601" cy="633546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EA92091-7A73-444C-A928-56370140DF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50890" y="3226819"/>
            <a:ext cx="2448240" cy="326432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722AEED6-857C-0F4D-B728-F7D56375C117}"/>
              </a:ext>
            </a:extLst>
          </p:cNvPr>
          <p:cNvSpPr txBox="1"/>
          <p:nvPr/>
        </p:nvSpPr>
        <p:spPr>
          <a:xfrm>
            <a:off x="4752818" y="6583220"/>
            <a:ext cx="1980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Goldman, M. Author Owned.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C1273A9-3A2E-E647-A15A-C1AE2D48D34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5393222" y="1472154"/>
            <a:ext cx="1718259" cy="1288694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C4337E5B-673C-744B-8EBC-8A5401682F07}"/>
              </a:ext>
            </a:extLst>
          </p:cNvPr>
          <p:cNvSpPr txBox="1"/>
          <p:nvPr/>
        </p:nvSpPr>
        <p:spPr>
          <a:xfrm>
            <a:off x="4659902" y="2972710"/>
            <a:ext cx="1980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Goldman, M. Author Owned.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4E4B256D-47BD-E148-8AE0-1C5C11FBD4A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5400000">
            <a:off x="4136541" y="1472261"/>
            <a:ext cx="1714798" cy="128609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9AEF8B1-3876-294C-AD9B-377B055F532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97894" y="168282"/>
            <a:ext cx="1082924" cy="81219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5A197FB-EF36-6E43-AD84-65116EA48E98}"/>
              </a:ext>
            </a:extLst>
          </p:cNvPr>
          <p:cNvSpPr txBox="1"/>
          <p:nvPr/>
        </p:nvSpPr>
        <p:spPr>
          <a:xfrm>
            <a:off x="4600417" y="995220"/>
            <a:ext cx="1980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Goldman, M. Author Owned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6B82615-2BCB-D544-9A2E-9E2AC474F19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08004" y="174169"/>
            <a:ext cx="1063784" cy="7978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3266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65</TotalTime>
  <Words>258</Words>
  <Application>Microsoft Macintosh PowerPoint</Application>
  <PresentationFormat>Widescreen</PresentationFormat>
  <Paragraphs>46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ldman, Michael</dc:creator>
  <cp:lastModifiedBy>Goldman, Michael</cp:lastModifiedBy>
  <cp:revision>13</cp:revision>
  <cp:lastPrinted>2018-03-05T17:50:08Z</cp:lastPrinted>
  <dcterms:created xsi:type="dcterms:W3CDTF">2018-02-24T19:45:31Z</dcterms:created>
  <dcterms:modified xsi:type="dcterms:W3CDTF">2020-01-20T15:09:41Z</dcterms:modified>
</cp:coreProperties>
</file>